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706" y="3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3A7C71-806A-0EC8-EAC9-7F99C660AA7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803CE44-433F-80F3-6022-B2429E8CFE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03DD04E-ACC3-F067-B327-D80CD715E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CC25-9532-4423-BED8-781BA65AD390}" type="datetimeFigureOut">
              <a:rPr lang="zh-CN" altLang="en-US" smtClean="0"/>
              <a:t>2025/7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32A8E5B-1521-1AB0-9FB1-244EB4059B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AE0D292-6BB2-021D-38A7-094B33A643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1CD27-E284-4D4B-A400-553961D835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690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00BE71-FB2F-336B-6A27-897BB72CBD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17F784A-307D-11B9-54F1-C62CC74F7E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9B9086F-F90D-C7E8-E561-A5C052775C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CC25-9532-4423-BED8-781BA65AD390}" type="datetimeFigureOut">
              <a:rPr lang="zh-CN" altLang="en-US" smtClean="0"/>
              <a:t>2025/7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C4FA4B-437D-8966-5402-94FAE00F3A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F39169D-CE2A-51B8-130C-2A5B68AADE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1CD27-E284-4D4B-A400-553961D835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56106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9AD8789-065B-1C0F-F524-CB0631D970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049632B-E1E7-2E18-890F-EDA12FB283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751F4DC-D310-DE39-A0BE-0705FAACBF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CC25-9532-4423-BED8-781BA65AD390}" type="datetimeFigureOut">
              <a:rPr lang="zh-CN" altLang="en-US" smtClean="0"/>
              <a:t>2025/7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5A67C26-7487-AE9E-03F3-EE4C4E3E5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4741F1E-CDB1-0476-BB89-A868DF5A92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1CD27-E284-4D4B-A400-553961D835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2199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6D9F557-97AC-82FB-C6A6-B87B0A83DC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F847F5-6C42-5E3F-65B0-A024733341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4FC2ECB-99C9-3707-E8EE-BC7C86CC38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CC25-9532-4423-BED8-781BA65AD390}" type="datetimeFigureOut">
              <a:rPr lang="zh-CN" altLang="en-US" smtClean="0"/>
              <a:t>2025/7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C164906-037C-4F1E-810B-473FFC55F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58B501C-1D0B-4366-9AAD-D22F32718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1CD27-E284-4D4B-A400-553961D835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265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3CE045-6BC6-EF2C-B0B5-D712E8C20A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FB62524-639D-53F9-1E7E-90EFF681D1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6788D58-E4DE-8096-9D9A-1B31D4C4CB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CC25-9532-4423-BED8-781BA65AD390}" type="datetimeFigureOut">
              <a:rPr lang="zh-CN" altLang="en-US" smtClean="0"/>
              <a:t>2025/7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C2F5D90-CE2C-2CA2-6A5B-AAD9D5D2B9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DAB5D4-B177-B8D5-A107-14E0A2E537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1CD27-E284-4D4B-A400-553961D835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63696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A657320-72B9-447E-5290-ABC3D76216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69C2A83-9596-A22C-5C8C-AD2CAC348E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1D7AEF3-C370-136D-2FD4-4DCDD21DA8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B5B3907-A9F0-3818-29BE-5063868D2C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CC25-9532-4423-BED8-781BA65AD390}" type="datetimeFigureOut">
              <a:rPr lang="zh-CN" altLang="en-US" smtClean="0"/>
              <a:t>2025/7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99F4B66-D28B-AD3D-0749-FB486EA210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66147FF-AC9E-5EA4-D5EA-FF79C36F39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1CD27-E284-4D4B-A400-553961D835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3740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DB374A1-393E-29AC-FA7C-854636F4AA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148A3C5-F216-F617-3675-5EC06C605C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BC0771A-E516-9080-DB18-4F5073BFB2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1F5C099-42BC-935E-F0AC-8D17860817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ACA7AB7-FAB3-E4DC-C01F-CBA1DCC8FC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8665D6E-F41F-FEF8-D500-26446D4803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CC25-9532-4423-BED8-781BA65AD390}" type="datetimeFigureOut">
              <a:rPr lang="zh-CN" altLang="en-US" smtClean="0"/>
              <a:t>2025/7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A893B7D-A8C1-DDE9-2E69-69F86E5CF1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78308DC-0101-FD53-369C-E2D14CB2E9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1CD27-E284-4D4B-A400-553961D835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84559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F3D62F3-F482-1F8B-B399-17099128BB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AD7C8BF-5D1B-B421-2A4A-1D9C8B2B68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CC25-9532-4423-BED8-781BA65AD390}" type="datetimeFigureOut">
              <a:rPr lang="zh-CN" altLang="en-US" smtClean="0"/>
              <a:t>2025/7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8F3B314-1980-271E-4D2D-E96E26F8AF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FB0224A-3D65-5DF8-2B96-6ADFE72981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1CD27-E284-4D4B-A400-553961D835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9795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E3498B9-3DD0-42E8-7668-ACB4687FB1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CC25-9532-4423-BED8-781BA65AD390}" type="datetimeFigureOut">
              <a:rPr lang="zh-CN" altLang="en-US" smtClean="0"/>
              <a:t>2025/7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B698315-35F5-26A0-8365-157177486C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EBCC371-5651-9040-97E6-45DD167DD2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1CD27-E284-4D4B-A400-553961D835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37115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6BC7169-5AA6-6652-9EED-064CEBE938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8949A5D-3C1F-BFDB-79D4-B0C62D4DC2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19EF9F2-BF8C-2B09-5A2D-45F22A3A25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58FBFED-7D3B-2BC5-DC5F-D9DD86E14C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CC25-9532-4423-BED8-781BA65AD390}" type="datetimeFigureOut">
              <a:rPr lang="zh-CN" altLang="en-US" smtClean="0"/>
              <a:t>2025/7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6DE082B-6E70-39A8-345B-888C6A3FB3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8ABA1B3-0F24-F1A2-56FC-5B88252AF1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1CD27-E284-4D4B-A400-553961D835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26968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C1C4D8F-4E03-5070-B57D-9456EC58AB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3068831-4F39-33C4-3FFE-602FD6BB6E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46E163C-230E-9903-5920-6EBBE3BC3F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302A7A4-44CE-D815-CAEE-6C4F766035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CC25-9532-4423-BED8-781BA65AD390}" type="datetimeFigureOut">
              <a:rPr lang="zh-CN" altLang="en-US" smtClean="0"/>
              <a:t>2025/7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67A1281-CC59-F8D9-CEF6-53D736AF76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D71E670-464A-19BF-4BDA-5D6A85F3C2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1CD27-E284-4D4B-A400-553961D835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3059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379515D-1A3E-4B41-346A-A6A0A8B8C1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FB19D5D-76C8-11A3-01F8-73114F0A89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0E7F1E1-B373-CBA1-492B-241E09C40D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96CC25-9532-4423-BED8-781BA65AD390}" type="datetimeFigureOut">
              <a:rPr lang="zh-CN" altLang="en-US" smtClean="0"/>
              <a:t>2025/7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25C99AB-853B-7E4D-068C-7A10DA6A5A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7ED92FD-A37E-B363-085C-11009E62D9C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C1CD27-E284-4D4B-A400-553961D835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59296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tif"/><Relationship Id="rId13" Type="http://schemas.openxmlformats.org/officeDocument/2006/relationships/image" Target="../media/image18.tif"/><Relationship Id="rId3" Type="http://schemas.openxmlformats.org/officeDocument/2006/relationships/image" Target="../media/image8.tif"/><Relationship Id="rId7" Type="http://schemas.openxmlformats.org/officeDocument/2006/relationships/image" Target="../media/image12.tif"/><Relationship Id="rId12" Type="http://schemas.openxmlformats.org/officeDocument/2006/relationships/image" Target="../media/image17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tif"/><Relationship Id="rId11" Type="http://schemas.openxmlformats.org/officeDocument/2006/relationships/image" Target="../media/image16.tif"/><Relationship Id="rId5" Type="http://schemas.openxmlformats.org/officeDocument/2006/relationships/image" Target="../media/image10.tif"/><Relationship Id="rId10" Type="http://schemas.openxmlformats.org/officeDocument/2006/relationships/image" Target="../media/image15.tif"/><Relationship Id="rId4" Type="http://schemas.openxmlformats.org/officeDocument/2006/relationships/image" Target="../media/image9.tif"/><Relationship Id="rId9" Type="http://schemas.openxmlformats.org/officeDocument/2006/relationships/image" Target="../media/image14.tif"/><Relationship Id="rId14" Type="http://schemas.openxmlformats.org/officeDocument/2006/relationships/image" Target="../media/image19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"/><Relationship Id="rId2" Type="http://schemas.openxmlformats.org/officeDocument/2006/relationships/image" Target="../media/image20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tif"/><Relationship Id="rId5" Type="http://schemas.openxmlformats.org/officeDocument/2006/relationships/image" Target="../media/image23.tif"/><Relationship Id="rId4" Type="http://schemas.openxmlformats.org/officeDocument/2006/relationships/image" Target="../media/image2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>
            <a:extLst>
              <a:ext uri="{FF2B5EF4-FFF2-40B4-BE49-F238E27FC236}">
                <a16:creationId xmlns:a16="http://schemas.microsoft.com/office/drawing/2014/main" id="{DF3F020A-044A-1460-2A8C-5EC005B971B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3648" y="1030524"/>
            <a:ext cx="2520000" cy="230321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584AC609-001B-22B2-5A32-7CECA82CDF3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2232" y="1030524"/>
            <a:ext cx="2520000" cy="1894900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FC15E53B-A862-8ABF-3B2A-87CAF57E520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0816" y="1030524"/>
            <a:ext cx="2520000" cy="2048970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5279873F-DB5D-5291-2E98-4F942FEFE16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3648" y="4100908"/>
            <a:ext cx="2520000" cy="86212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2113CD4A-B5C0-F985-B3B6-B2FE1F23005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2232" y="4100908"/>
            <a:ext cx="2520000" cy="1899730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2622DB77-C4CA-4D3D-4B33-3562D6A9E76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0816" y="4100908"/>
            <a:ext cx="2520000" cy="2048200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9336CF62-7C1D-E9D8-41B5-0BE4EBA8B217}"/>
              </a:ext>
            </a:extLst>
          </p:cNvPr>
          <p:cNvSpPr txBox="1"/>
          <p:nvPr/>
        </p:nvSpPr>
        <p:spPr>
          <a:xfrm>
            <a:off x="5809498" y="6000638"/>
            <a:ext cx="5730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/>
              <a:t>Bax</a:t>
            </a:r>
            <a:endParaRPr lang="zh-CN" altLang="en-US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C1AC366B-98FD-7F54-E814-9E798FD44119}"/>
              </a:ext>
            </a:extLst>
          </p:cNvPr>
          <p:cNvSpPr txBox="1"/>
          <p:nvPr/>
        </p:nvSpPr>
        <p:spPr>
          <a:xfrm>
            <a:off x="9154527" y="6149108"/>
            <a:ext cx="87981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Bcl-2</a:t>
            </a: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428A5CA6-4463-150D-60F1-C72FA45EDF07}"/>
              </a:ext>
            </a:extLst>
          </p:cNvPr>
          <p:cNvSpPr txBox="1"/>
          <p:nvPr/>
        </p:nvSpPr>
        <p:spPr>
          <a:xfrm>
            <a:off x="2392780" y="3333734"/>
            <a:ext cx="8016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/>
              <a:t>COX2</a:t>
            </a:r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1EF50CA1-98D0-9051-1B2E-20ABD34EBE38}"/>
              </a:ext>
            </a:extLst>
          </p:cNvPr>
          <p:cNvSpPr txBox="1"/>
          <p:nvPr/>
        </p:nvSpPr>
        <p:spPr>
          <a:xfrm>
            <a:off x="5748426" y="2966377"/>
            <a:ext cx="6951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/>
              <a:t>iNOS</a:t>
            </a:r>
            <a:endParaRPr lang="zh-CN" altLang="en-US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01C60045-AA0E-FD7E-A003-52DFB8032840}"/>
              </a:ext>
            </a:extLst>
          </p:cNvPr>
          <p:cNvSpPr txBox="1"/>
          <p:nvPr/>
        </p:nvSpPr>
        <p:spPr>
          <a:xfrm>
            <a:off x="8997615" y="3036203"/>
            <a:ext cx="89785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β-actin</a:t>
            </a: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C70A5608-CC6A-DFA0-797B-076B97473502}"/>
              </a:ext>
            </a:extLst>
          </p:cNvPr>
          <p:cNvSpPr txBox="1"/>
          <p:nvPr/>
        </p:nvSpPr>
        <p:spPr>
          <a:xfrm>
            <a:off x="2248745" y="4991538"/>
            <a:ext cx="1036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β-actin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EB93F03C-71F8-7007-6C3B-0B216D9B7DD9}"/>
              </a:ext>
            </a:extLst>
          </p:cNvPr>
          <p:cNvSpPr txBox="1"/>
          <p:nvPr/>
        </p:nvSpPr>
        <p:spPr>
          <a:xfrm>
            <a:off x="537028" y="323594"/>
            <a:ext cx="12192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2400" b="1" dirty="0"/>
              <a:t>Fig6</a:t>
            </a:r>
          </a:p>
        </p:txBody>
      </p:sp>
    </p:spTree>
    <p:extLst>
      <p:ext uri="{BB962C8B-B14F-4D97-AF65-F5344CB8AC3E}">
        <p14:creationId xmlns:p14="http://schemas.microsoft.com/office/powerpoint/2010/main" val="21466249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7D8E421C-623F-BF57-AC6F-4712B44170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4962" y="4674992"/>
            <a:ext cx="2088000" cy="157655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7CA52F0D-0029-F68D-113E-3B9D48E6AA8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056" y="507354"/>
            <a:ext cx="2088000" cy="1205356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AF005D00-B1D7-42C8-ADC4-C98F1856EB2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5384" y="478326"/>
            <a:ext cx="2088000" cy="1263356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C43BF523-FF91-2E40-8E9F-57F752B2600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5384" y="2394079"/>
            <a:ext cx="2088000" cy="1491876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2156CB8B-E8BC-6500-75AD-E3ED2C8AD31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00040" y="296900"/>
            <a:ext cx="2088000" cy="1661468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EC27ED9B-9570-53A8-B62A-733932D9364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22367" y="2394079"/>
            <a:ext cx="2088000" cy="1785008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2804B779-6F96-5856-D6C7-66B280534FF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056" y="4559539"/>
            <a:ext cx="2088000" cy="1929022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5A094671-5EE9-338E-4014-A681087CCAA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056" y="2394079"/>
            <a:ext cx="2088000" cy="1597552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A87B4689-ABC7-764C-E852-343E43797CA0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22367" y="296900"/>
            <a:ext cx="2088000" cy="1233428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EFD0B2A8-E910-7AD0-9173-B0B268AF54F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7712" y="296900"/>
            <a:ext cx="2088000" cy="1540654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A6167D2E-5380-5DF1-84B6-6751F8157797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7712" y="2394079"/>
            <a:ext cx="2088000" cy="1971710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DE269D4D-C22C-10AE-9282-CE0E0C2BF3DA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7712" y="4933822"/>
            <a:ext cx="2088000" cy="1633570"/>
          </a:xfrm>
          <a:prstGeom prst="rect">
            <a:avLst/>
          </a:prstGeom>
        </p:spPr>
      </p:pic>
      <p:sp>
        <p:nvSpPr>
          <p:cNvPr id="35" name="文本框 34">
            <a:extLst>
              <a:ext uri="{FF2B5EF4-FFF2-40B4-BE49-F238E27FC236}">
                <a16:creationId xmlns:a16="http://schemas.microsoft.com/office/drawing/2014/main" id="{FC4378A7-84C3-FD44-AEDF-4F1C12DA0B6C}"/>
              </a:ext>
            </a:extLst>
          </p:cNvPr>
          <p:cNvSpPr txBox="1"/>
          <p:nvPr/>
        </p:nvSpPr>
        <p:spPr>
          <a:xfrm>
            <a:off x="10325481" y="1481549"/>
            <a:ext cx="18062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/>
              <a:t>Cytosol NF-κB</a:t>
            </a:r>
            <a:endParaRPr lang="zh-CN" altLang="en-US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A65F33CC-B220-2BEF-3149-FC52320609EE}"/>
              </a:ext>
            </a:extLst>
          </p:cNvPr>
          <p:cNvSpPr txBox="1"/>
          <p:nvPr/>
        </p:nvSpPr>
        <p:spPr>
          <a:xfrm>
            <a:off x="3445609" y="6181382"/>
            <a:ext cx="7294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ERK</a:t>
            </a: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2DB42C40-33A3-78BF-F77D-CC8F5F3B3730}"/>
              </a:ext>
            </a:extLst>
          </p:cNvPr>
          <p:cNvSpPr txBox="1"/>
          <p:nvPr/>
        </p:nvSpPr>
        <p:spPr>
          <a:xfrm>
            <a:off x="987014" y="1656608"/>
            <a:ext cx="8437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IL-1β</a:t>
            </a: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FDFDB252-BC94-C6A4-D805-CD6BF57D3728}"/>
              </a:ext>
            </a:extLst>
          </p:cNvPr>
          <p:cNvSpPr txBox="1"/>
          <p:nvPr/>
        </p:nvSpPr>
        <p:spPr>
          <a:xfrm>
            <a:off x="3506109" y="1718075"/>
            <a:ext cx="62113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/>
              <a:t>IL-6</a:t>
            </a:r>
            <a:endParaRPr lang="zh-CN" altLang="en-US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120C4044-B6E0-5E48-F926-B337C02B6967}"/>
              </a:ext>
            </a:extLst>
          </p:cNvPr>
          <p:cNvSpPr txBox="1"/>
          <p:nvPr/>
        </p:nvSpPr>
        <p:spPr>
          <a:xfrm>
            <a:off x="3588962" y="3872063"/>
            <a:ext cx="65121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JNK</a:t>
            </a: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DE6D4531-6F10-CDFA-6954-15AED46CB501}"/>
              </a:ext>
            </a:extLst>
          </p:cNvPr>
          <p:cNvSpPr txBox="1"/>
          <p:nvPr/>
        </p:nvSpPr>
        <p:spPr>
          <a:xfrm>
            <a:off x="7896446" y="1898471"/>
            <a:ext cx="18062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Nuclear NF-κB</a:t>
            </a: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DB2F8421-B3C6-DCF4-49A5-58B144E5DA7B}"/>
              </a:ext>
            </a:extLst>
          </p:cNvPr>
          <p:cNvSpPr txBox="1"/>
          <p:nvPr/>
        </p:nvSpPr>
        <p:spPr>
          <a:xfrm>
            <a:off x="10938239" y="4162579"/>
            <a:ext cx="7474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P38</a:t>
            </a: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1D250DBF-C382-F06C-88E3-705A4D43FE07}"/>
              </a:ext>
            </a:extLst>
          </p:cNvPr>
          <p:cNvSpPr txBox="1"/>
          <p:nvPr/>
        </p:nvSpPr>
        <p:spPr>
          <a:xfrm>
            <a:off x="950211" y="6536200"/>
            <a:ext cx="9098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/>
              <a:t>P-ERK</a:t>
            </a:r>
            <a:endParaRPr lang="zh-CN" altLang="en-US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A1595ACC-0CB3-DA21-C1AA-75FD7AE8CCB3}"/>
              </a:ext>
            </a:extLst>
          </p:cNvPr>
          <p:cNvSpPr txBox="1"/>
          <p:nvPr/>
        </p:nvSpPr>
        <p:spPr>
          <a:xfrm>
            <a:off x="992976" y="3987149"/>
            <a:ext cx="8677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/>
              <a:t>P-JNK</a:t>
            </a:r>
            <a:endParaRPr lang="zh-CN" altLang="en-US" dirty="0"/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384022C1-AD95-EC43-2A19-B485D79E1979}"/>
              </a:ext>
            </a:extLst>
          </p:cNvPr>
          <p:cNvSpPr txBox="1"/>
          <p:nvPr/>
        </p:nvSpPr>
        <p:spPr>
          <a:xfrm>
            <a:off x="8253248" y="4075638"/>
            <a:ext cx="8677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P-P38</a:t>
            </a: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AE964A48-C52A-138F-5AF2-35BF16D59F30}"/>
              </a:ext>
            </a:extLst>
          </p:cNvPr>
          <p:cNvSpPr txBox="1"/>
          <p:nvPr/>
        </p:nvSpPr>
        <p:spPr>
          <a:xfrm>
            <a:off x="5767464" y="4306909"/>
            <a:ext cx="9219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β-actin</a:t>
            </a: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63885CF3-E5EF-A389-1039-9772CEB935FB}"/>
              </a:ext>
            </a:extLst>
          </p:cNvPr>
          <p:cNvSpPr txBox="1"/>
          <p:nvPr/>
        </p:nvSpPr>
        <p:spPr>
          <a:xfrm>
            <a:off x="5721369" y="6536200"/>
            <a:ext cx="9219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β-actin</a:t>
            </a:r>
          </a:p>
        </p:txBody>
      </p:sp>
      <p:pic>
        <p:nvPicPr>
          <p:cNvPr id="58" name="图片 57">
            <a:extLst>
              <a:ext uri="{FF2B5EF4-FFF2-40B4-BE49-F238E27FC236}">
                <a16:creationId xmlns:a16="http://schemas.microsoft.com/office/drawing/2014/main" id="{6581CF41-E804-67CC-C816-7E2BE403105A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00040" y="2394079"/>
            <a:ext cx="2088000" cy="1720912"/>
          </a:xfrm>
          <a:prstGeom prst="rect">
            <a:avLst/>
          </a:prstGeom>
        </p:spPr>
      </p:pic>
      <p:sp>
        <p:nvSpPr>
          <p:cNvPr id="59" name="文本框 58">
            <a:extLst>
              <a:ext uri="{FF2B5EF4-FFF2-40B4-BE49-F238E27FC236}">
                <a16:creationId xmlns:a16="http://schemas.microsoft.com/office/drawing/2014/main" id="{7F1BDF89-AF60-2ED9-ED4F-78DFA88F9711}"/>
              </a:ext>
            </a:extLst>
          </p:cNvPr>
          <p:cNvSpPr txBox="1"/>
          <p:nvPr/>
        </p:nvSpPr>
        <p:spPr>
          <a:xfrm>
            <a:off x="5810846" y="1751416"/>
            <a:ext cx="9219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β-actin</a:t>
            </a: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315091D7-C024-0D02-6025-DD5D040D44AF}"/>
              </a:ext>
            </a:extLst>
          </p:cNvPr>
          <p:cNvSpPr txBox="1"/>
          <p:nvPr/>
        </p:nvSpPr>
        <p:spPr>
          <a:xfrm>
            <a:off x="-42144" y="-1950"/>
            <a:ext cx="12192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2400" b="1" dirty="0"/>
              <a:t>Fig</a:t>
            </a:r>
            <a:r>
              <a:rPr lang="en-US" altLang="zh-CN" sz="2400" b="1" dirty="0"/>
              <a:t>7</a:t>
            </a:r>
            <a:endParaRPr lang="zh-CN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40757791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85055BA-BE97-72BB-77A4-8ABF58A7823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5448" y="1259615"/>
            <a:ext cx="1908000" cy="164103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E43F144-B108-4A0D-BCC1-EE3AC408B82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1598" y="1259641"/>
            <a:ext cx="1908000" cy="1691654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7E487821-AC9F-B680-2B7E-E7E345A3DB3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67748" y="1259616"/>
            <a:ext cx="1908000" cy="1656197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9CF16DEB-08E7-8BF0-6BC3-6D506B895DD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5448" y="3762802"/>
            <a:ext cx="1908000" cy="1523167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94EBBD6D-94A8-FDAE-E7BE-EB8D43D0946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1598" y="3762802"/>
            <a:ext cx="1908000" cy="1540233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686F1DB9-A8ED-2C87-958F-47ADE000D3FA}"/>
              </a:ext>
            </a:extLst>
          </p:cNvPr>
          <p:cNvSpPr txBox="1"/>
          <p:nvPr/>
        </p:nvSpPr>
        <p:spPr>
          <a:xfrm>
            <a:off x="3077029" y="2900654"/>
            <a:ext cx="12845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/>
              <a:t>Caspase-1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A6423070-35DA-C537-9B6C-974C5CE92527}"/>
              </a:ext>
            </a:extLst>
          </p:cNvPr>
          <p:cNvSpPr txBox="1"/>
          <p:nvPr/>
        </p:nvSpPr>
        <p:spPr>
          <a:xfrm>
            <a:off x="5685244" y="2951295"/>
            <a:ext cx="105228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/>
              <a:t>GSDMD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FCDD69F0-0138-4A6B-4ED1-3150F7AEC3C3}"/>
              </a:ext>
            </a:extLst>
          </p:cNvPr>
          <p:cNvSpPr txBox="1"/>
          <p:nvPr/>
        </p:nvSpPr>
        <p:spPr>
          <a:xfrm>
            <a:off x="8367486" y="2919440"/>
            <a:ext cx="76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/>
              <a:t>IL-1β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A4132AD0-2DC2-B199-0B7B-A95B890EF6D0}"/>
              </a:ext>
            </a:extLst>
          </p:cNvPr>
          <p:cNvSpPr txBox="1"/>
          <p:nvPr/>
        </p:nvSpPr>
        <p:spPr>
          <a:xfrm>
            <a:off x="3247571" y="5285969"/>
            <a:ext cx="9434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NLRP3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2F128C77-F044-6F2C-3A39-D6C0778DA9A4}"/>
              </a:ext>
            </a:extLst>
          </p:cNvPr>
          <p:cNvSpPr txBox="1"/>
          <p:nvPr/>
        </p:nvSpPr>
        <p:spPr>
          <a:xfrm>
            <a:off x="5762172" y="5303035"/>
            <a:ext cx="105228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β-actin</a:t>
            </a: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C2B6B9B4-F005-C0BB-2A44-216EF3CD3A05}"/>
              </a:ext>
            </a:extLst>
          </p:cNvPr>
          <p:cNvSpPr txBox="1"/>
          <p:nvPr/>
        </p:nvSpPr>
        <p:spPr>
          <a:xfrm>
            <a:off x="537028" y="323594"/>
            <a:ext cx="12192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2400" b="1" dirty="0"/>
              <a:t>Fig</a:t>
            </a:r>
            <a:r>
              <a:rPr lang="en-US" altLang="zh-CN" sz="2400" b="1" dirty="0"/>
              <a:t>8</a:t>
            </a:r>
            <a:endParaRPr lang="zh-CN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14648725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72</Words>
  <Application>Microsoft Office PowerPoint</Application>
  <PresentationFormat>宽屏</PresentationFormat>
  <Paragraphs>27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Y Zhu</dc:creator>
  <cp:lastModifiedBy>ZY Zhu</cp:lastModifiedBy>
  <cp:revision>4</cp:revision>
  <dcterms:created xsi:type="dcterms:W3CDTF">2025-07-18T14:08:51Z</dcterms:created>
  <dcterms:modified xsi:type="dcterms:W3CDTF">2025-07-18T14:35:59Z</dcterms:modified>
</cp:coreProperties>
</file>